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wmf" ContentType="image/x-wmf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2CEC7E-21A7-425D-81C9-3A809B0118B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DD6D55-DE47-4786-A85E-FC577B411B5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F6582A-2A11-461A-BD89-3170F927651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4E3B64-8CF1-416C-881E-1F407A460B8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6EB687-9D57-45F7-BD1F-C03B33FC4C5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761B8F-837F-40FB-9B7E-D3E6D72E531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B23272-9FB4-41AF-B5D6-5CADEE3DE2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C704D4-EE60-4C29-9B5F-64EAEBE665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53C1CE-BE4E-4964-97CB-AAF8D6039D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ACDAC0-E404-4B65-A077-F95048CA4D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CE6044-96F6-47A5-80DB-B9F036FEEF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4E2C74-57BD-495F-A0DC-4983C2DE92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197D46F-08E2-4899-90E2-978F6877C000}" type="slidenum">
              <a:rPr b="0" lang="en-CA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wmf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33"/>
          <p:cNvGrpSpPr/>
          <p:nvPr/>
        </p:nvGrpSpPr>
        <p:grpSpPr>
          <a:xfrm>
            <a:off x="1341360" y="3782520"/>
            <a:ext cx="4340160" cy="1220760"/>
            <a:chOff x="1341360" y="3782520"/>
            <a:chExt cx="4340160" cy="1220760"/>
          </a:xfrm>
        </p:grpSpPr>
        <p:pic>
          <p:nvPicPr>
            <p:cNvPr id="43" name="Picture 4" descr=""/>
            <p:cNvPicPr/>
            <p:nvPr/>
          </p:nvPicPr>
          <p:blipFill>
            <a:blip r:embed="rId1"/>
            <a:stretch/>
          </p:blipFill>
          <p:spPr>
            <a:xfrm>
              <a:off x="1793520" y="4628880"/>
              <a:ext cx="3888000" cy="361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Text Box 5"/>
            <p:cNvSpPr/>
            <p:nvPr/>
          </p:nvSpPr>
          <p:spPr>
            <a:xfrm rot="16200000">
              <a:off x="1872720" y="4317480"/>
              <a:ext cx="377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 Box 6"/>
            <p:cNvSpPr/>
            <p:nvPr/>
          </p:nvSpPr>
          <p:spPr>
            <a:xfrm rot="16200000">
              <a:off x="1991880" y="4082760"/>
              <a:ext cx="846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+NTC -GCV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7"/>
            <p:cNvSpPr/>
            <p:nvPr/>
          </p:nvSpPr>
          <p:spPr>
            <a:xfrm rot="16200000">
              <a:off x="3149280" y="4082760"/>
              <a:ext cx="846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+NTC -GCV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 Box 8"/>
            <p:cNvSpPr/>
            <p:nvPr/>
          </p:nvSpPr>
          <p:spPr>
            <a:xfrm rot="16200000">
              <a:off x="4228560" y="4082760"/>
              <a:ext cx="846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+NTC -GCV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9"/>
            <p:cNvSpPr/>
            <p:nvPr/>
          </p:nvSpPr>
          <p:spPr>
            <a:xfrm rot="16200000">
              <a:off x="4603320" y="4096800"/>
              <a:ext cx="817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-NTC -GCV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10"/>
            <p:cNvSpPr/>
            <p:nvPr/>
          </p:nvSpPr>
          <p:spPr>
            <a:xfrm rot="16200000">
              <a:off x="3524040" y="4109760"/>
              <a:ext cx="817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-NTC -GCV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11"/>
            <p:cNvSpPr/>
            <p:nvPr/>
          </p:nvSpPr>
          <p:spPr>
            <a:xfrm rot="16200000">
              <a:off x="2415960" y="4109760"/>
              <a:ext cx="817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-NTC -GCV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12"/>
            <p:cNvSpPr/>
            <p:nvPr/>
          </p:nvSpPr>
          <p:spPr>
            <a:xfrm rot="16200000">
              <a:off x="2788920" y="4095360"/>
              <a:ext cx="846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-NTC +GCV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13"/>
            <p:cNvSpPr/>
            <p:nvPr/>
          </p:nvSpPr>
          <p:spPr>
            <a:xfrm rot="16200000">
              <a:off x="3870000" y="4082760"/>
              <a:ext cx="846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-NTC +GCV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14"/>
            <p:cNvSpPr/>
            <p:nvPr/>
          </p:nvSpPr>
          <p:spPr>
            <a:xfrm rot="16200000">
              <a:off x="4949280" y="4082760"/>
              <a:ext cx="846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-NTC +GCV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 Box 19"/>
            <p:cNvSpPr/>
            <p:nvPr/>
          </p:nvSpPr>
          <p:spPr>
            <a:xfrm>
              <a:off x="1341360" y="4694040"/>
              <a:ext cx="811080" cy="309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54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 Box 20"/>
            <p:cNvSpPr/>
            <p:nvPr/>
          </p:nvSpPr>
          <p:spPr>
            <a:xfrm>
              <a:off x="1358640" y="4384440"/>
              <a:ext cx="866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21"/>
            <p:cNvSpPr/>
            <p:nvPr/>
          </p:nvSpPr>
          <p:spPr>
            <a:xfrm>
              <a:off x="1707840" y="4849560"/>
              <a:ext cx="104760" cy="0"/>
            </a:xfrm>
            <a:prstGeom prst="line">
              <a:avLst/>
            </a:prstGeom>
            <a:ln w="50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7" name="Text Box 34"/>
          <p:cNvSpPr/>
          <p:nvPr/>
        </p:nvSpPr>
        <p:spPr>
          <a:xfrm>
            <a:off x="601560" y="5526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35"/>
          <p:cNvSpPr/>
          <p:nvPr/>
        </p:nvSpPr>
        <p:spPr>
          <a:xfrm>
            <a:off x="615600" y="343224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Picture 41" descr=""/>
          <p:cNvPicPr/>
          <p:nvPr/>
        </p:nvPicPr>
        <p:blipFill>
          <a:blip r:embed="rId2"/>
          <a:stretch/>
        </p:blipFill>
        <p:spPr>
          <a:xfrm>
            <a:off x="1628640" y="900000"/>
            <a:ext cx="3508560" cy="1481400"/>
          </a:xfrm>
          <a:prstGeom prst="rect">
            <a:avLst/>
          </a:prstGeom>
          <a:ln w="0">
            <a:noFill/>
          </a:ln>
        </p:spPr>
      </p:pic>
      <p:sp>
        <p:nvSpPr>
          <p:cNvPr id="60" name="Text Box 42"/>
          <p:cNvSpPr/>
          <p:nvPr/>
        </p:nvSpPr>
        <p:spPr>
          <a:xfrm>
            <a:off x="623880" y="55213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Picture 1" descr="100914_LIM_S1_scan.png"/>
          <p:cNvPicPr/>
          <p:nvPr/>
        </p:nvPicPr>
        <p:blipFill>
          <a:blip r:embed="rId3"/>
          <a:stretch/>
        </p:blipFill>
        <p:spPr>
          <a:xfrm>
            <a:off x="189000" y="6767640"/>
            <a:ext cx="2016000" cy="155880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1" descr="100914_LIM_S10_scan.png"/>
          <p:cNvPicPr/>
          <p:nvPr/>
        </p:nvPicPr>
        <p:blipFill>
          <a:blip r:embed="rId4"/>
          <a:stretch/>
        </p:blipFill>
        <p:spPr>
          <a:xfrm>
            <a:off x="2421000" y="6759720"/>
            <a:ext cx="2016000" cy="1557360"/>
          </a:xfrm>
          <a:prstGeom prst="rect">
            <a:avLst/>
          </a:prstGeom>
          <a:ln w="0">
            <a:noFill/>
          </a:ln>
        </p:spPr>
      </p:pic>
      <p:sp>
        <p:nvSpPr>
          <p:cNvPr id="63" name="Rectangle 62"/>
          <p:cNvSpPr/>
          <p:nvPr/>
        </p:nvSpPr>
        <p:spPr>
          <a:xfrm>
            <a:off x="692280" y="6227640"/>
            <a:ext cx="1008000" cy="289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Times New Roman"/>
              </a:rPr>
              <a:t>Wild-typ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63"/>
          <p:cNvSpPr/>
          <p:nvPr/>
        </p:nvSpPr>
        <p:spPr>
          <a:xfrm>
            <a:off x="2708280" y="6157800"/>
            <a:ext cx="1800360" cy="287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Times New Roman"/>
              </a:rPr>
              <a:t>HKO1 + CYP + PAC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Times New Roman"/>
              </a:rPr>
              <a:t> –</a:t>
            </a:r>
            <a:r>
              <a:rPr b="0" lang="en-CA" sz="1000" spc="-1" strike="noStrike">
                <a:solidFill>
                  <a:srgbClr val="000000"/>
                </a:solidFill>
                <a:latin typeface="Times New Roman"/>
              </a:rPr>
              <a:t>NTC +GC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" name="Picture 1" descr="100914_LIM_S9_scan.png"/>
          <p:cNvPicPr/>
          <p:nvPr/>
        </p:nvPicPr>
        <p:blipFill>
          <a:blip r:embed="rId5"/>
          <a:stretch/>
        </p:blipFill>
        <p:spPr>
          <a:xfrm>
            <a:off x="4653000" y="6757920"/>
            <a:ext cx="2016000" cy="1559160"/>
          </a:xfrm>
          <a:prstGeom prst="rect">
            <a:avLst/>
          </a:prstGeom>
          <a:ln w="0">
            <a:noFill/>
          </a:ln>
        </p:spPr>
      </p:pic>
      <p:sp>
        <p:nvSpPr>
          <p:cNvPr id="66" name="Rectangle 65"/>
          <p:cNvSpPr/>
          <p:nvPr/>
        </p:nvSpPr>
        <p:spPr>
          <a:xfrm>
            <a:off x="4941720" y="6156360"/>
            <a:ext cx="1800360" cy="287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Times New Roman"/>
              </a:rPr>
              <a:t>HKO2 + CYP + PAC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Times New Roman"/>
              </a:rPr>
              <a:t> –</a:t>
            </a:r>
            <a:r>
              <a:rPr b="0" lang="en-CA" sz="1000" spc="-1" strike="noStrike">
                <a:solidFill>
                  <a:srgbClr val="000000"/>
                </a:solidFill>
                <a:latin typeface="Times New Roman"/>
              </a:rPr>
              <a:t>NTC +GC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66"/>
          <p:cNvSpPr/>
          <p:nvPr/>
        </p:nvSpPr>
        <p:spPr>
          <a:xfrm>
            <a:off x="406080" y="7164360"/>
            <a:ext cx="43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Times New Roman"/>
              </a:rPr>
              <a:t>chol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67"/>
          <p:cNvSpPr/>
          <p:nvPr/>
        </p:nvSpPr>
        <p:spPr>
          <a:xfrm>
            <a:off x="2707920" y="7164360"/>
            <a:ext cx="43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Times New Roman"/>
              </a:rPr>
              <a:t>chol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68"/>
          <p:cNvSpPr/>
          <p:nvPr/>
        </p:nvSpPr>
        <p:spPr>
          <a:xfrm>
            <a:off x="4939920" y="7164360"/>
            <a:ext cx="43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Times New Roman"/>
              </a:rPr>
              <a:t>chol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69"/>
          <p:cNvSpPr/>
          <p:nvPr/>
        </p:nvSpPr>
        <p:spPr>
          <a:xfrm>
            <a:off x="5283360" y="7164360"/>
            <a:ext cx="37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Times New Roman"/>
              </a:rPr>
              <a:t>erg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70"/>
          <p:cNvSpPr/>
          <p:nvPr/>
        </p:nvSpPr>
        <p:spPr>
          <a:xfrm>
            <a:off x="3070440" y="7164360"/>
            <a:ext cx="37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Times New Roman"/>
              </a:rPr>
              <a:t>erg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71"/>
          <p:cNvSpPr/>
          <p:nvPr/>
        </p:nvSpPr>
        <p:spPr>
          <a:xfrm>
            <a:off x="766800" y="7164360"/>
            <a:ext cx="37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Times New Roman"/>
              </a:rPr>
              <a:t>erg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72"/>
          <p:cNvSpPr/>
          <p:nvPr/>
        </p:nvSpPr>
        <p:spPr>
          <a:xfrm>
            <a:off x="836640" y="6632640"/>
            <a:ext cx="79848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Times New Roman"/>
              </a:rPr>
              <a:t>episte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73"/>
          <p:cNvSpPr/>
          <p:nvPr/>
        </p:nvSpPr>
        <p:spPr>
          <a:xfrm>
            <a:off x="3141720" y="6659640"/>
            <a:ext cx="79848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Times New Roman"/>
              </a:rPr>
              <a:t>episte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74"/>
          <p:cNvSpPr/>
          <p:nvPr/>
        </p:nvSpPr>
        <p:spPr>
          <a:xfrm>
            <a:off x="5367240" y="6632640"/>
            <a:ext cx="79848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Times New Roman"/>
              </a:rPr>
              <a:t>episte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75"/>
          <p:cNvSpPr/>
          <p:nvPr/>
        </p:nvSpPr>
        <p:spPr>
          <a:xfrm>
            <a:off x="1341360" y="7236000"/>
            <a:ext cx="79848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Times New Roman"/>
              </a:rPr>
              <a:t>fecoste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76"/>
          <p:cNvSpPr/>
          <p:nvPr/>
        </p:nvSpPr>
        <p:spPr>
          <a:xfrm>
            <a:off x="1550880" y="7640640"/>
            <a:ext cx="79848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Times New Roman"/>
              </a:rPr>
              <a:t>lanoste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ine 78"/>
          <p:cNvSpPr/>
          <p:nvPr/>
        </p:nvSpPr>
        <p:spPr>
          <a:xfrm flipH="1">
            <a:off x="1341360" y="7451640"/>
            <a:ext cx="287280" cy="360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79"/>
          <p:cNvSpPr/>
          <p:nvPr/>
        </p:nvSpPr>
        <p:spPr>
          <a:xfrm flipH="1">
            <a:off x="1484280" y="7885080"/>
            <a:ext cx="504720" cy="2160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80"/>
          <p:cNvSpPr/>
          <p:nvPr/>
        </p:nvSpPr>
        <p:spPr>
          <a:xfrm>
            <a:off x="3645000" y="7236000"/>
            <a:ext cx="79848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Times New Roman"/>
              </a:rPr>
              <a:t>fecoste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81"/>
          <p:cNvSpPr/>
          <p:nvPr/>
        </p:nvSpPr>
        <p:spPr>
          <a:xfrm>
            <a:off x="3854520" y="7640640"/>
            <a:ext cx="79848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Times New Roman"/>
              </a:rPr>
              <a:t>lanoste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84"/>
          <p:cNvSpPr/>
          <p:nvPr/>
        </p:nvSpPr>
        <p:spPr>
          <a:xfrm>
            <a:off x="5877000" y="7236000"/>
            <a:ext cx="79848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Times New Roman"/>
              </a:rPr>
              <a:t>fecoste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85"/>
          <p:cNvSpPr/>
          <p:nvPr/>
        </p:nvSpPr>
        <p:spPr>
          <a:xfrm>
            <a:off x="6086520" y="7640640"/>
            <a:ext cx="79848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Times New Roman"/>
              </a:rPr>
              <a:t>lanoste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86"/>
          <p:cNvSpPr/>
          <p:nvPr/>
        </p:nvSpPr>
        <p:spPr>
          <a:xfrm flipH="1">
            <a:off x="5877000" y="7451640"/>
            <a:ext cx="287280" cy="360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89"/>
          <p:cNvSpPr/>
          <p:nvPr/>
        </p:nvSpPr>
        <p:spPr>
          <a:xfrm flipH="1">
            <a:off x="6021360" y="7812000"/>
            <a:ext cx="432000" cy="2160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Line 90"/>
          <p:cNvSpPr/>
          <p:nvPr/>
        </p:nvSpPr>
        <p:spPr>
          <a:xfrm flipH="1">
            <a:off x="3644640" y="7451640"/>
            <a:ext cx="360360" cy="360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Line 91"/>
          <p:cNvSpPr/>
          <p:nvPr/>
        </p:nvSpPr>
        <p:spPr>
          <a:xfrm flipH="1">
            <a:off x="3789000" y="7812000"/>
            <a:ext cx="431640" cy="2160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92"/>
          <p:cNvSpPr/>
          <p:nvPr/>
        </p:nvSpPr>
        <p:spPr>
          <a:xfrm>
            <a:off x="874080" y="8388360"/>
            <a:ext cx="82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Times New Roman"/>
              </a:rPr>
              <a:t>4006.6 pm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93"/>
          <p:cNvSpPr/>
          <p:nvPr/>
        </p:nvSpPr>
        <p:spPr>
          <a:xfrm>
            <a:off x="3107520" y="8388360"/>
            <a:ext cx="82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Times New Roman"/>
              </a:rPr>
              <a:t>7422.2 pm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94"/>
          <p:cNvSpPr/>
          <p:nvPr/>
        </p:nvSpPr>
        <p:spPr>
          <a:xfrm>
            <a:off x="5344560" y="8388360"/>
            <a:ext cx="82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Times New Roman"/>
              </a:rPr>
              <a:t>5421.9 pm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95"/>
          <p:cNvSpPr/>
          <p:nvPr/>
        </p:nvSpPr>
        <p:spPr>
          <a:xfrm>
            <a:off x="38160" y="8388360"/>
            <a:ext cx="724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Times New Roman"/>
              </a:rPr>
              <a:t>Erg. level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7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0-26T17:25:58Z</dcterms:created>
  <dc:creator>Laura-Isobel</dc:creator>
  <dc:description/>
  <dc:language>en-US</dc:language>
  <cp:lastModifiedBy>Laura-Isobel</cp:lastModifiedBy>
  <dcterms:modified xsi:type="dcterms:W3CDTF">2015-01-29T03:10:46Z</dcterms:modified>
  <cp:revision>17</cp:revision>
  <dc:subject/>
  <dc:title>Slide 1</dc:title>
</cp:coreProperties>
</file>